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47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5438DF2-CBFE-4296-9B1E-3CA63B84B4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CA1775A-9656-428D-AEA7-E41A37E4F6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11BD0EC-A060-466B-A922-7578E52DB9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B2566-6BED-40C1-8C27-FEDAE72E0778}" type="datetimeFigureOut">
              <a:rPr lang="es-CL" smtClean="0"/>
              <a:t>16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87E1879-1F69-4221-8EAA-4D027877F0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466813A-C046-492D-B1FE-82909411F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A65DC-70A8-4548-A856-398EB98AAF9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804169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3306D7B-8BF1-490A-A465-0A5D8DE41B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7094C8F-BDE2-44DE-8A14-8B05FE29B6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D1A0BC0-7B47-4104-8503-798ED27E70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B2566-6BED-40C1-8C27-FEDAE72E0778}" type="datetimeFigureOut">
              <a:rPr lang="es-CL" smtClean="0"/>
              <a:t>16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5123B3F-B66C-43BF-8601-F9CAE71F1A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F0D922C-E4CA-4661-8B31-D0D27CE15C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A65DC-70A8-4548-A856-398EB98AAF9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9511746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B5F370CD-E3C3-4644-89ED-674B2DA412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9505FB9-E155-4162-A77E-2095FF4621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DEFB033-AF6A-4E0F-8499-C7D5C14976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B2566-6BED-40C1-8C27-FEDAE72E0778}" type="datetimeFigureOut">
              <a:rPr lang="es-CL" smtClean="0"/>
              <a:t>16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8DD8713-E814-4A20-9079-1B90A0C43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E440E44-5E4D-4D9D-8834-1D500C37A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A65DC-70A8-4548-A856-398EB98AAF9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176252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195E02C-022A-4FAD-B443-A2C0FF1FB2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3AE491F-D669-4977-891D-A8025638F6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801E094-75BE-4CED-A301-40AD82E50B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B2566-6BED-40C1-8C27-FEDAE72E0778}" type="datetimeFigureOut">
              <a:rPr lang="es-CL" smtClean="0"/>
              <a:t>16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7FA5A14-C0EE-4ACE-96E6-17785DD226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32E51F4-CFAF-4989-B1C7-AD7FC68908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A65DC-70A8-4548-A856-398EB98AAF9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171654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A4BFB6F-3904-4079-8570-25FD392A76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1471482-1644-4C50-9768-0E17820D03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1CF694D-BBA9-4C60-8DB8-DEB150FFE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B2566-6BED-40C1-8C27-FEDAE72E0778}" type="datetimeFigureOut">
              <a:rPr lang="es-CL" smtClean="0"/>
              <a:t>16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9F51592-0EAC-4DBB-B364-30102C2D0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067CEE4-89B7-4ACD-BB27-7382FB75C8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A65DC-70A8-4548-A856-398EB98AAF9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822220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7344B7D-8F69-4A37-B348-4592DEDC22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51327B8-3032-4991-A269-9EA78D065E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31E23FC7-7AA6-4544-BAB6-72B9C246AF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19CB43A-73B1-4FCE-8E4F-8C5DB12519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B2566-6BED-40C1-8C27-FEDAE72E0778}" type="datetimeFigureOut">
              <a:rPr lang="es-CL" smtClean="0"/>
              <a:t>16-05-20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63D6087-AFE1-4480-9E8B-3D101D5A57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14AD293-3665-430A-AE2F-FD0321919D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A65DC-70A8-4548-A856-398EB98AAF9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901234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1F72BBC-A310-4A3A-8C75-25AA1E1646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5A4AA22-0774-4366-AE65-7BC96D8BD7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215788A8-F27F-4E0A-9A0F-9F3205E247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CED6D340-1CF7-4CF2-B4DA-1083C49746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E21D9099-F81F-4255-A862-6D269935FD3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3D062848-4C80-4A80-9160-3036A8DFFF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B2566-6BED-40C1-8C27-FEDAE72E0778}" type="datetimeFigureOut">
              <a:rPr lang="es-CL" smtClean="0"/>
              <a:t>16-05-2024</a:t>
            </a:fld>
            <a:endParaRPr lang="es-C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33D6845C-A441-4201-B973-6B8F19CFB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374C6F77-47ED-4410-8E56-03E77B15B0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A65DC-70A8-4548-A856-398EB98AAF9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088256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B7EA254-8318-47A3-8B81-E0F6579B28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386C251F-27E9-46BD-B05D-893D27EF6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B2566-6BED-40C1-8C27-FEDAE72E0778}" type="datetimeFigureOut">
              <a:rPr lang="es-CL" smtClean="0"/>
              <a:t>16-05-2024</a:t>
            </a:fld>
            <a:endParaRPr lang="es-C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9B0AE996-80B3-400A-94A6-82C4581786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622F4860-1E5C-43B2-B636-4A55AF57C3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A65DC-70A8-4548-A856-398EB98AAF9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21381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4CC303FC-1BE7-43DB-B658-4B4780E407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B2566-6BED-40C1-8C27-FEDAE72E0778}" type="datetimeFigureOut">
              <a:rPr lang="es-CL" smtClean="0"/>
              <a:t>16-05-2024</a:t>
            </a:fld>
            <a:endParaRPr lang="es-C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5306DF79-598A-404E-82B5-D9FDF8D3F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0ACA1D66-0B8B-46B5-8237-7EC5382C79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A65DC-70A8-4548-A856-398EB98AAF9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257624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4B010CE-4F5F-4058-BED3-FE50ED1EFD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AB78712-D1E5-4497-9023-207B1625E1D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AA5BA88-073F-4C7F-B169-1D782ACF51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2C3ED53-CC1B-48F8-A22E-5BBC4FB8BB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B2566-6BED-40C1-8C27-FEDAE72E0778}" type="datetimeFigureOut">
              <a:rPr lang="es-CL" smtClean="0"/>
              <a:t>16-05-20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A71F02D-B2B1-46BE-B746-9BF73195E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A2BAA16-D600-4C6A-8D6B-ED723CC75F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A65DC-70A8-4548-A856-398EB98AAF9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4322214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B15E28C-B2A3-4287-922F-C89D2D2808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890FDD9B-94DC-41AA-B191-298EC84EC44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7D9755F4-8610-4935-9E8C-581E11DBAD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B2795AF-38A0-4063-9B48-A431105377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B2566-6BED-40C1-8C27-FEDAE72E0778}" type="datetimeFigureOut">
              <a:rPr lang="es-CL" smtClean="0"/>
              <a:t>16-05-20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010E95E-CC64-4D36-93A0-3A4F98C517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3917DD3-EB50-48C5-B460-21FB8386E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A65DC-70A8-4548-A856-398EB98AAF9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589419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E62E5548-38E9-4918-8FAA-34E801C1FF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B857762-48A9-424A-9A49-F712E717D8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7CF1386-1E51-4A3B-893B-15A67690F8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8B2566-6BED-40C1-8C27-FEDAE72E0778}" type="datetimeFigureOut">
              <a:rPr lang="es-CL" smtClean="0"/>
              <a:t>16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6307E8F-86F3-4656-B269-8F0163C22B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EDDBC6F-99B6-42AE-A3D2-16E94030E9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FA65DC-70A8-4548-A856-398EB98AAF9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091193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upo 14">
            <a:extLst>
              <a:ext uri="{FF2B5EF4-FFF2-40B4-BE49-F238E27FC236}">
                <a16:creationId xmlns:a16="http://schemas.microsoft.com/office/drawing/2014/main" id="{EDE825F1-5BD7-4525-AF6B-9FD5F3CBC1F3}"/>
              </a:ext>
            </a:extLst>
          </p:cNvPr>
          <p:cNvGrpSpPr/>
          <p:nvPr/>
        </p:nvGrpSpPr>
        <p:grpSpPr>
          <a:xfrm>
            <a:off x="1331277" y="1374140"/>
            <a:ext cx="9529445" cy="4109720"/>
            <a:chOff x="1331277" y="1374140"/>
            <a:chExt cx="9529445" cy="4109720"/>
          </a:xfrm>
        </p:grpSpPr>
        <p:pic>
          <p:nvPicPr>
            <p:cNvPr id="18" name="Imagen 17">
              <a:extLst>
                <a:ext uri="{FF2B5EF4-FFF2-40B4-BE49-F238E27FC236}">
                  <a16:creationId xmlns:a16="http://schemas.microsoft.com/office/drawing/2014/main" id="{82604331-81A0-4D37-ADC8-553F0F2DB51B}"/>
                </a:ext>
              </a:extLst>
            </p:cNvPr>
            <p:cNvPicPr/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0"/>
                      </a14:imgEffect>
                      <a14:imgEffect>
                        <a14:brightnessContrast bright="-5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31277" y="1374140"/>
              <a:ext cx="9529445" cy="4109720"/>
            </a:xfrm>
            <a:prstGeom prst="rect">
              <a:avLst/>
            </a:prstGeom>
            <a:noFill/>
          </p:spPr>
        </p:pic>
        <p:sp>
          <p:nvSpPr>
            <p:cNvPr id="19" name="Elipse 18">
              <a:extLst>
                <a:ext uri="{FF2B5EF4-FFF2-40B4-BE49-F238E27FC236}">
                  <a16:creationId xmlns:a16="http://schemas.microsoft.com/office/drawing/2014/main" id="{D01F0A1A-5510-4303-83EB-1915C799AE7C}"/>
                </a:ext>
              </a:extLst>
            </p:cNvPr>
            <p:cNvSpPr/>
            <p:nvPr/>
          </p:nvSpPr>
          <p:spPr>
            <a:xfrm>
              <a:off x="10072052" y="3484880"/>
              <a:ext cx="276225" cy="228600"/>
            </a:xfrm>
            <a:prstGeom prst="ellips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s-CL"/>
            </a:p>
          </p:txBody>
        </p:sp>
        <p:sp>
          <p:nvSpPr>
            <p:cNvPr id="20" name="Elipse 19">
              <a:extLst>
                <a:ext uri="{FF2B5EF4-FFF2-40B4-BE49-F238E27FC236}">
                  <a16:creationId xmlns:a16="http://schemas.microsoft.com/office/drawing/2014/main" id="{E6592FFD-4A24-4B17-A68E-D3040675551F}"/>
                </a:ext>
              </a:extLst>
            </p:cNvPr>
            <p:cNvSpPr/>
            <p:nvPr/>
          </p:nvSpPr>
          <p:spPr>
            <a:xfrm>
              <a:off x="9722167" y="3646805"/>
              <a:ext cx="171450" cy="161925"/>
            </a:xfrm>
            <a:prstGeom prst="ellips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s-CL"/>
            </a:p>
          </p:txBody>
        </p:sp>
        <p:sp>
          <p:nvSpPr>
            <p:cNvPr id="21" name="Cuadro de texto 14">
              <a:extLst>
                <a:ext uri="{FF2B5EF4-FFF2-40B4-BE49-F238E27FC236}">
                  <a16:creationId xmlns:a16="http://schemas.microsoft.com/office/drawing/2014/main" id="{AC894CB1-8087-4CD5-88DE-CAFEDDB89AB6}"/>
                </a:ext>
              </a:extLst>
            </p:cNvPr>
            <p:cNvSpPr txBox="1"/>
            <p:nvPr/>
          </p:nvSpPr>
          <p:spPr>
            <a:xfrm>
              <a:off x="9688512" y="3183255"/>
              <a:ext cx="382905" cy="371475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Bef>
                  <a:spcPts val="600"/>
                </a:spcBef>
                <a:spcAft>
                  <a:spcPts val="1200"/>
                </a:spcAft>
              </a:pPr>
              <a:r>
                <a:rPr lang="es-CL" sz="1200" b="1">
                  <a:ln>
                    <a:noFill/>
                  </a:ln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3</a:t>
              </a:r>
              <a:endParaRPr lang="es-C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2" name="Cuadro de texto 12">
              <a:extLst>
                <a:ext uri="{FF2B5EF4-FFF2-40B4-BE49-F238E27FC236}">
                  <a16:creationId xmlns:a16="http://schemas.microsoft.com/office/drawing/2014/main" id="{C2CA8A66-9038-4B8C-B579-478C7800BBEF}"/>
                </a:ext>
              </a:extLst>
            </p:cNvPr>
            <p:cNvSpPr txBox="1"/>
            <p:nvPr/>
          </p:nvSpPr>
          <p:spPr>
            <a:xfrm>
              <a:off x="10012997" y="3188970"/>
              <a:ext cx="419100" cy="371475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Bef>
                  <a:spcPts val="600"/>
                </a:spcBef>
                <a:spcAft>
                  <a:spcPts val="1200"/>
                </a:spcAft>
              </a:pPr>
              <a:r>
                <a:rPr lang="es-CL" sz="1200" b="1">
                  <a:ln>
                    <a:noFill/>
                  </a:ln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1</a:t>
              </a:r>
              <a:endParaRPr lang="es-C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3" name="Cuadro de texto 13">
              <a:extLst>
                <a:ext uri="{FF2B5EF4-FFF2-40B4-BE49-F238E27FC236}">
                  <a16:creationId xmlns:a16="http://schemas.microsoft.com/office/drawing/2014/main" id="{4972DB79-42E4-48E3-8B25-E7C9023F98FF}"/>
                </a:ext>
              </a:extLst>
            </p:cNvPr>
            <p:cNvSpPr txBox="1"/>
            <p:nvPr/>
          </p:nvSpPr>
          <p:spPr>
            <a:xfrm>
              <a:off x="9675812" y="3689985"/>
              <a:ext cx="419100" cy="371475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Bef>
                  <a:spcPts val="600"/>
                </a:spcBef>
                <a:spcAft>
                  <a:spcPts val="1200"/>
                </a:spcAft>
              </a:pPr>
              <a:r>
                <a:rPr lang="es-CL" sz="1200" b="1">
                  <a:ln>
                    <a:noFill/>
                  </a:ln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2</a:t>
              </a:r>
              <a:endParaRPr lang="es-C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4" name="Elipse 23">
              <a:extLst>
                <a:ext uri="{FF2B5EF4-FFF2-40B4-BE49-F238E27FC236}">
                  <a16:creationId xmlns:a16="http://schemas.microsoft.com/office/drawing/2014/main" id="{AF14530A-022B-4E5D-92FD-10B5F03B1E48}"/>
                </a:ext>
              </a:extLst>
            </p:cNvPr>
            <p:cNvSpPr/>
            <p:nvPr/>
          </p:nvSpPr>
          <p:spPr>
            <a:xfrm>
              <a:off x="8201977" y="5050155"/>
              <a:ext cx="200025" cy="161925"/>
            </a:xfrm>
            <a:prstGeom prst="ellips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s-CL"/>
            </a:p>
          </p:txBody>
        </p:sp>
        <p:sp>
          <p:nvSpPr>
            <p:cNvPr id="25" name="Cuadro de texto 15">
              <a:extLst>
                <a:ext uri="{FF2B5EF4-FFF2-40B4-BE49-F238E27FC236}">
                  <a16:creationId xmlns:a16="http://schemas.microsoft.com/office/drawing/2014/main" id="{30508D2D-648C-4736-9C22-C3F56A5FE5E2}"/>
                </a:ext>
              </a:extLst>
            </p:cNvPr>
            <p:cNvSpPr txBox="1"/>
            <p:nvPr/>
          </p:nvSpPr>
          <p:spPr>
            <a:xfrm>
              <a:off x="8261032" y="4916805"/>
              <a:ext cx="419100" cy="371475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Bef>
                  <a:spcPts val="600"/>
                </a:spcBef>
                <a:spcAft>
                  <a:spcPts val="1200"/>
                </a:spcAft>
              </a:pPr>
              <a:r>
                <a:rPr lang="es-CL" sz="1200" b="1">
                  <a:ln>
                    <a:noFill/>
                  </a:ln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4</a:t>
              </a:r>
              <a:endParaRPr lang="es-C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6" name="Elipse 25">
              <a:extLst>
                <a:ext uri="{FF2B5EF4-FFF2-40B4-BE49-F238E27FC236}">
                  <a16:creationId xmlns:a16="http://schemas.microsoft.com/office/drawing/2014/main" id="{73F962CB-9DA7-4A6C-A9A1-972D432722E8}"/>
                </a:ext>
              </a:extLst>
            </p:cNvPr>
            <p:cNvSpPr/>
            <p:nvPr/>
          </p:nvSpPr>
          <p:spPr>
            <a:xfrm>
              <a:off x="9718553" y="3456305"/>
              <a:ext cx="276225" cy="190500"/>
            </a:xfrm>
            <a:prstGeom prst="ellips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s-CL"/>
            </a:p>
          </p:txBody>
        </p:sp>
      </p:grpSp>
      <p:sp>
        <p:nvSpPr>
          <p:cNvPr id="29" name="CuadroTexto 28">
            <a:extLst>
              <a:ext uri="{FF2B5EF4-FFF2-40B4-BE49-F238E27FC236}">
                <a16:creationId xmlns:a16="http://schemas.microsoft.com/office/drawing/2014/main" id="{7AE3D614-C77D-4B50-A6B1-ED17255B1085}"/>
              </a:ext>
            </a:extLst>
          </p:cNvPr>
          <p:cNvSpPr txBox="1"/>
          <p:nvPr/>
        </p:nvSpPr>
        <p:spPr>
          <a:xfrm>
            <a:off x="1255102" y="5613400"/>
            <a:ext cx="1022765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2-D Electrophoresis gels of proteins extracted from cultures of </a:t>
            </a:r>
            <a:r>
              <a:rPr lang="en-US" i="1" dirty="0" err="1"/>
              <a:t>Leptospirillum</a:t>
            </a:r>
            <a:r>
              <a:rPr lang="en-US" i="1" dirty="0"/>
              <a:t> </a:t>
            </a:r>
            <a:r>
              <a:rPr lang="en-US" i="1" dirty="0" err="1"/>
              <a:t>ferriphilum</a:t>
            </a:r>
            <a:r>
              <a:rPr lang="en-US" i="1" dirty="0"/>
              <a:t> </a:t>
            </a:r>
            <a:r>
              <a:rPr lang="en-US" dirty="0"/>
              <a:t>IESL25, grown in the presence of 8 g/L (A) and 80 g/L (B) of sulfate. Identified proteins (Table 1) are indicated in panel.</a:t>
            </a:r>
            <a:endParaRPr lang="es-CL" dirty="0"/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A0DDF5EB-DB2B-4617-9B15-0BCEF12C9028}"/>
              </a:ext>
            </a:extLst>
          </p:cNvPr>
          <p:cNvSpPr txBox="1"/>
          <p:nvPr/>
        </p:nvSpPr>
        <p:spPr>
          <a:xfrm>
            <a:off x="1255102" y="598269"/>
            <a:ext cx="60974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1</a:t>
            </a:r>
            <a:endParaRPr lang="es-CL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99153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870F5C5C-7AFB-4C95-8A09-D000AC9EB745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2944" y="571500"/>
            <a:ext cx="6334125" cy="4852035"/>
          </a:xfrm>
          <a:prstGeom prst="rect">
            <a:avLst/>
          </a:prstGeom>
          <a:noFill/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D9DB501C-CE6E-42D6-9AC1-E18E9A715E45}"/>
              </a:ext>
            </a:extLst>
          </p:cNvPr>
          <p:cNvSpPr txBox="1"/>
          <p:nvPr/>
        </p:nvSpPr>
        <p:spPr>
          <a:xfrm>
            <a:off x="1844187" y="386834"/>
            <a:ext cx="60974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2</a:t>
            </a:r>
            <a:endParaRPr lang="es-CL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28D0CFE7-94BB-4039-9D31-1196B4E375FC}"/>
              </a:ext>
            </a:extLst>
          </p:cNvPr>
          <p:cNvSpPr txBox="1"/>
          <p:nvPr/>
        </p:nvSpPr>
        <p:spPr>
          <a:xfrm>
            <a:off x="1395778" y="5648989"/>
            <a:ext cx="979682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Phylogenetic affiliation of 16S rRNA gene sequence of strain IESL 25. Database accession numbers are indicated between brackets. The scale bar corresponds to 0.02 mutations per nucleotide position.</a:t>
            </a:r>
          </a:p>
        </p:txBody>
      </p:sp>
    </p:spTree>
    <p:extLst>
      <p:ext uri="{BB962C8B-B14F-4D97-AF65-F5344CB8AC3E}">
        <p14:creationId xmlns:p14="http://schemas.microsoft.com/office/powerpoint/2010/main" val="8423974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id="{F1FCD136-86D6-4B7D-B9B6-CAEEECDA57AC}"/>
              </a:ext>
            </a:extLst>
          </p:cNvPr>
          <p:cNvSpPr txBox="1"/>
          <p:nvPr/>
        </p:nvSpPr>
        <p:spPr>
          <a:xfrm>
            <a:off x="1123218" y="474757"/>
            <a:ext cx="60974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CL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1. 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1FB1B9B6-3E6E-4C9F-B93E-835D39AFC283}"/>
              </a:ext>
            </a:extLst>
          </p:cNvPr>
          <p:cNvSpPr txBox="1"/>
          <p:nvPr/>
        </p:nvSpPr>
        <p:spPr>
          <a:xfrm>
            <a:off x="1219933" y="1046257"/>
            <a:ext cx="609746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ata supplied by Delta 2D 4.0 imaging software.</a:t>
            </a:r>
            <a:endParaRPr lang="es-CL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aphicFrame>
        <p:nvGraphicFramePr>
          <p:cNvPr id="6" name="Tabla 5">
            <a:extLst>
              <a:ext uri="{FF2B5EF4-FFF2-40B4-BE49-F238E27FC236}">
                <a16:creationId xmlns:a16="http://schemas.microsoft.com/office/drawing/2014/main" id="{B32D8630-1E94-48C8-B2B7-30C8B44561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873511"/>
              </p:ext>
            </p:extLst>
          </p:nvPr>
        </p:nvGraphicFramePr>
        <p:xfrm>
          <a:off x="1321776" y="1556202"/>
          <a:ext cx="6629400" cy="1135380"/>
        </p:xfrm>
        <a:graphic>
          <a:graphicData uri="http://schemas.openxmlformats.org/drawingml/2006/table">
            <a:tbl>
              <a:tblPr/>
              <a:tblGrid>
                <a:gridCol w="787400">
                  <a:extLst>
                    <a:ext uri="{9D8B030D-6E8A-4147-A177-3AD203B41FA5}">
                      <a16:colId xmlns:a16="http://schemas.microsoft.com/office/drawing/2014/main" val="1847197208"/>
                    </a:ext>
                  </a:extLst>
                </a:gridCol>
                <a:gridCol w="1041400">
                  <a:extLst>
                    <a:ext uri="{9D8B030D-6E8A-4147-A177-3AD203B41FA5}">
                      <a16:colId xmlns:a16="http://schemas.microsoft.com/office/drawing/2014/main" val="3857526575"/>
                    </a:ext>
                  </a:extLst>
                </a:gridCol>
                <a:gridCol w="1041400">
                  <a:extLst>
                    <a:ext uri="{9D8B030D-6E8A-4147-A177-3AD203B41FA5}">
                      <a16:colId xmlns:a16="http://schemas.microsoft.com/office/drawing/2014/main" val="2175454029"/>
                    </a:ext>
                  </a:extLst>
                </a:gridCol>
                <a:gridCol w="1079500">
                  <a:extLst>
                    <a:ext uri="{9D8B030D-6E8A-4147-A177-3AD203B41FA5}">
                      <a16:colId xmlns:a16="http://schemas.microsoft.com/office/drawing/2014/main" val="3919963759"/>
                    </a:ext>
                  </a:extLst>
                </a:gridCol>
                <a:gridCol w="1041400">
                  <a:extLst>
                    <a:ext uri="{9D8B030D-6E8A-4147-A177-3AD203B41FA5}">
                      <a16:colId xmlns:a16="http://schemas.microsoft.com/office/drawing/2014/main" val="3814913379"/>
                    </a:ext>
                  </a:extLst>
                </a:gridCol>
                <a:gridCol w="1638300">
                  <a:extLst>
                    <a:ext uri="{9D8B030D-6E8A-4147-A177-3AD203B41FA5}">
                      <a16:colId xmlns:a16="http://schemas.microsoft.com/office/drawing/2014/main" val="2708245549"/>
                    </a:ext>
                  </a:extLst>
                </a:gridCol>
              </a:tblGrid>
              <a:tr h="373380">
                <a:tc>
                  <a:txBody>
                    <a:bodyPr/>
                    <a:lstStyle/>
                    <a:p>
                      <a:pPr algn="ctr" font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Spot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Average Volume (8 g/L Sulfate)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Standard deviation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 Average Volume (83 g/L Sulfate)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Standard deviation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Mean Normalized Volume (Fold change)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522902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1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0,115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0,021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2,375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0,177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20,65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960225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2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0,185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0,085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1,775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0,177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9,59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730503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3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0,345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0,092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1,795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0,148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5,20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02535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4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3,500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0,707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0,113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0,018</a:t>
                      </a:r>
                      <a:endParaRPr lang="es-CL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0,03</a:t>
                      </a:r>
                      <a:endParaRPr lang="es-CL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894163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4944468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56</Words>
  <Application>Microsoft Office PowerPoint</Application>
  <PresentationFormat>Panorámica</PresentationFormat>
  <Paragraphs>40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edro A. Galleguillos</dc:creator>
  <cp:lastModifiedBy>Pedro A. Galleguillos</cp:lastModifiedBy>
  <cp:revision>2</cp:revision>
  <dcterms:created xsi:type="dcterms:W3CDTF">2024-05-16T16:55:34Z</dcterms:created>
  <dcterms:modified xsi:type="dcterms:W3CDTF">2024-05-16T17:05:06Z</dcterms:modified>
</cp:coreProperties>
</file>